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30"/>
    <p:restoredTop sz="94619"/>
  </p:normalViewPr>
  <p:slideViewPr>
    <p:cSldViewPr snapToGrid="0">
      <p:cViewPr varScale="1">
        <p:scale>
          <a:sx n="113" d="100"/>
          <a:sy n="113" d="100"/>
        </p:scale>
        <p:origin x="192" y="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399559-74A1-E63D-6939-7856717E54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30E3F27-09D9-6F4B-4F54-6B3B07AB56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8E5EDE-51C3-E4C8-2DF1-CD85E57820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7A277A-C5DA-0779-1D82-6092B7A83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45BB2D-A3E7-D49E-E2FD-2C48E5138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74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526E7C-0006-46E7-1B13-329A1C2995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DF9A8A-81F4-FCDB-0876-662C32FB54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70FF74-D1E7-CC5D-AEE5-A21C1BAD7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3E3114-5E03-CEFA-601E-136DCD300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DE286B-916F-17EE-701E-2F58109D5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429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4F59A2-9623-A6B0-0DAF-556DC05A88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77FFB1-E755-1B74-F50F-A5D4A3A38E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671518-C8E8-B4ED-04D9-E843C6DAD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533D6A-8694-3DBA-903C-10B275EF5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2DCD01-779E-B34F-38A5-915F4DD8E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594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48C617-FC27-B2B4-3490-8F0227DC3F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23413A-A9B7-F44E-4413-8768E802E1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32728-8E8D-26D0-3B25-CCF0632EC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E56522-8954-D550-E0D4-714665D6A7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8DDBE3-EF52-30B7-4B11-93533A72F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191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3C5696-C134-7CAB-78B9-843FCFD3CF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2BD7B4-40A9-BD60-E492-F58F304C29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F98A31-2E27-DE32-B4DC-1B6A8643D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554410-1014-869B-26B5-0095B5D90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AEE85C-46D6-CE00-4CDB-0C17AC6CB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089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D7ECF6-3224-097B-9A16-513DAD5BE5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D70A1F-0079-E738-10AF-39409EF7F8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06DD9F-765C-9226-9F14-A759C0D131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16B671-9FBB-FB90-0666-662790ADA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1F48D5-63B9-9504-2166-49CB2A56F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B3F67C-E754-3303-4274-C1D4F7586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1033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AAC958-C60F-F403-B437-07399D55AF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FCB9FB-327B-24DD-DF2F-BCC65F7EB3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4BCF67-BA54-5D90-2429-C1F87B8692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32F882D-CD67-1D01-8A87-249FA60D2E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B87702-18CE-DE1D-3759-4E3E7D03E6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F264CB-03C9-FDFE-2EC7-98143B2D7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2FD305-54CA-36AA-20DD-664199FA4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E571BAC-FD4E-414D-DD99-FB4D431C7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762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DD451E-FDCE-5371-095B-B3C2724285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1146F0-A76E-3AD1-5A57-6A36DDDE7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E1766E-4813-0F5D-F86B-BDFAC498F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6E91B6-182C-9205-A039-78DF8E675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921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FF51A9-4D78-5227-5D80-6F6F902C5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A31FEF-4DEF-6882-6736-EF1E6FF88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97F0CD-E514-B4B4-343A-4E7BE4622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739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065C71-4E13-815B-AD99-F90AAED336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41E507-A56C-C9FB-AE24-1528C94D17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B83856-B92A-ED0C-1A9E-00C3EFB162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5D09D8-5038-4D3D-C400-07ACA121F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4A13F0-3E5D-25E7-5C4A-2C471C6AA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488B88-C3FD-5C01-7F52-EB6E8CDFF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015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C859CB-26CC-A261-2774-BE2A5469DE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2CF0A1-B261-D6F2-E494-0D1AD4E57D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EFEFAE-7436-51DD-98F9-229FD6AE3B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39F115-8699-1781-59DA-978DAD43C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EB18D7-6691-EC00-6936-8DB327666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60537D-B3E4-2BA1-78F1-B9013610D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698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D4C8C6-CD63-6EA7-7715-A24938258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6C1C6A-6681-1F2D-197F-AC6A03C870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0AE005-DF8F-E04C-7D20-916EFB5337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2F8A5-66A7-E648-9C8A-72001CCD0DBD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6D8B63-F4EF-E8C5-9EA0-BC7100CAB0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A30BD0-2851-6792-EB96-2F9D6F2EDE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C5BBFD-D126-7F4C-A620-BD5F9FCE2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477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BACAC491-31D1-B35A-04CB-F717DFA770D5}"/>
              </a:ext>
            </a:extLst>
          </p:cNvPr>
          <p:cNvCxnSpPr/>
          <p:nvPr/>
        </p:nvCxnSpPr>
        <p:spPr>
          <a:xfrm>
            <a:off x="951139" y="2719269"/>
            <a:ext cx="10372725" cy="0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D210E670-264B-F100-9B9E-AD47AA4DF31E}"/>
              </a:ext>
            </a:extLst>
          </p:cNvPr>
          <p:cNvCxnSpPr>
            <a:cxnSpLocks/>
          </p:cNvCxnSpPr>
          <p:nvPr/>
        </p:nvCxnSpPr>
        <p:spPr>
          <a:xfrm flipV="1">
            <a:off x="1669596" y="2566869"/>
            <a:ext cx="0" cy="329293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0F65B738-38FF-9B87-012C-4DCBA5B1A77B}"/>
              </a:ext>
            </a:extLst>
          </p:cNvPr>
          <p:cNvSpPr txBox="1"/>
          <p:nvPr/>
        </p:nvSpPr>
        <p:spPr>
          <a:xfrm>
            <a:off x="951139" y="1828205"/>
            <a:ext cx="14444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AD completed by patien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20A3CE5-52B4-0A13-10DE-BEEC6D4ABEF5}"/>
              </a:ext>
            </a:extLst>
          </p:cNvPr>
          <p:cNvSpPr txBox="1"/>
          <p:nvPr/>
        </p:nvSpPr>
        <p:spPr>
          <a:xfrm>
            <a:off x="4969748" y="1873169"/>
            <a:ext cx="12776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SURGERY</a:t>
            </a:r>
          </a:p>
          <a:p>
            <a:pPr algn="ctr"/>
            <a:r>
              <a:rPr lang="en-US" sz="1400" b="1" dirty="0"/>
              <a:t>Admission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AAA70ED-6B18-C282-322A-580CD83C18BC}"/>
              </a:ext>
            </a:extLst>
          </p:cNvPr>
          <p:cNvCxnSpPr>
            <a:cxnSpLocks/>
          </p:cNvCxnSpPr>
          <p:nvPr/>
        </p:nvCxnSpPr>
        <p:spPr>
          <a:xfrm flipV="1">
            <a:off x="4771039" y="2520607"/>
            <a:ext cx="0" cy="329293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D8CC7D7B-EDC5-16A5-A91C-3EF21BF9348A}"/>
              </a:ext>
            </a:extLst>
          </p:cNvPr>
          <p:cNvSpPr txBox="1"/>
          <p:nvPr/>
        </p:nvSpPr>
        <p:spPr>
          <a:xfrm>
            <a:off x="4780424" y="3821364"/>
            <a:ext cx="1727372" cy="16004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linician </a:t>
            </a:r>
            <a:r>
              <a:rPr lang="en-US" sz="1400" b="1" dirty="0"/>
              <a:t>reviews existing ACP documentation</a:t>
            </a:r>
            <a:r>
              <a:rPr lang="en-US" sz="1400" dirty="0"/>
              <a:t>, discusses with patient &amp; documents updates on admission orders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C221CBD-3642-098E-BA64-1F8A1F470F73}"/>
              </a:ext>
            </a:extLst>
          </p:cNvPr>
          <p:cNvCxnSpPr>
            <a:cxnSpLocks/>
          </p:cNvCxnSpPr>
          <p:nvPr/>
        </p:nvCxnSpPr>
        <p:spPr>
          <a:xfrm flipV="1">
            <a:off x="10363787" y="2554622"/>
            <a:ext cx="0" cy="329293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4752727A-7C2C-342A-9838-CA45F1BE0537}"/>
              </a:ext>
            </a:extLst>
          </p:cNvPr>
          <p:cNvSpPr txBox="1"/>
          <p:nvPr/>
        </p:nvSpPr>
        <p:spPr>
          <a:xfrm>
            <a:off x="9628341" y="1600515"/>
            <a:ext cx="147089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ACP discussed and updated in postoperative setting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1657133-3D88-0084-E76A-C91706759869}"/>
              </a:ext>
            </a:extLst>
          </p:cNvPr>
          <p:cNvSpPr txBox="1"/>
          <p:nvPr/>
        </p:nvSpPr>
        <p:spPr>
          <a:xfrm>
            <a:off x="2301556" y="1830519"/>
            <a:ext cx="246948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AD scanned into EHR at clinic visit or hospital admissio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A2E718A-9108-3115-4028-2EC571B1DE02}"/>
              </a:ext>
            </a:extLst>
          </p:cNvPr>
          <p:cNvSpPr txBox="1"/>
          <p:nvPr/>
        </p:nvSpPr>
        <p:spPr>
          <a:xfrm>
            <a:off x="6370097" y="1890209"/>
            <a:ext cx="1632623" cy="523220"/>
          </a:xfrm>
          <a:prstGeom prst="rect">
            <a:avLst/>
          </a:prstGeom>
          <a:noFill/>
          <a:ln w="50800">
            <a:solidFill>
              <a:srgbClr val="FF0000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UNPLANNED ICU ADMISS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5D74ABB-8E32-2E19-0D49-61E87079E637}"/>
              </a:ext>
            </a:extLst>
          </p:cNvPr>
          <p:cNvSpPr txBox="1"/>
          <p:nvPr/>
        </p:nvSpPr>
        <p:spPr>
          <a:xfrm>
            <a:off x="1795629" y="3882920"/>
            <a:ext cx="297050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linician </a:t>
            </a:r>
            <a:r>
              <a:rPr lang="en-US" sz="1400" b="1" dirty="0"/>
              <a:t>reviews existing ACP documentation</a:t>
            </a:r>
            <a:r>
              <a:rPr lang="en-US" sz="1400" dirty="0"/>
              <a:t>, discusses &amp; writes ACP update in context of new conditions, as appropriat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5BCEF65-FBCB-B14E-5764-57C524F6DDEA}"/>
              </a:ext>
            </a:extLst>
          </p:cNvPr>
          <p:cNvSpPr/>
          <p:nvPr/>
        </p:nvSpPr>
        <p:spPr>
          <a:xfrm>
            <a:off x="756745" y="756745"/>
            <a:ext cx="3699641" cy="45194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OUTPATIENT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EB91A6D-64B3-A1F9-A01C-4226753EB8DD}"/>
              </a:ext>
            </a:extLst>
          </p:cNvPr>
          <p:cNvSpPr/>
          <p:nvPr/>
        </p:nvSpPr>
        <p:spPr>
          <a:xfrm>
            <a:off x="4671848" y="753245"/>
            <a:ext cx="3699641" cy="45194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INPATIENT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21B39C1-8434-1E26-C735-30A2F5E6EC30}"/>
              </a:ext>
            </a:extLst>
          </p:cNvPr>
          <p:cNvSpPr/>
          <p:nvPr/>
        </p:nvSpPr>
        <p:spPr>
          <a:xfrm>
            <a:off x="8613321" y="739234"/>
            <a:ext cx="2710544" cy="45194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OUTPATIEN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880EE94-A766-53B4-A57B-69D5331C1602}"/>
              </a:ext>
            </a:extLst>
          </p:cNvPr>
          <p:cNvSpPr txBox="1"/>
          <p:nvPr/>
        </p:nvSpPr>
        <p:spPr>
          <a:xfrm>
            <a:off x="8080600" y="1381586"/>
            <a:ext cx="127767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Patient discharged</a:t>
            </a:r>
          </a:p>
          <a:p>
            <a:pPr algn="ctr"/>
            <a:r>
              <a:rPr lang="en-US" sz="1400" b="1" dirty="0"/>
              <a:t>Home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9797A16-D3C5-0D13-5042-70054934614C}"/>
              </a:ext>
            </a:extLst>
          </p:cNvPr>
          <p:cNvCxnSpPr>
            <a:cxnSpLocks/>
          </p:cNvCxnSpPr>
          <p:nvPr/>
        </p:nvCxnSpPr>
        <p:spPr>
          <a:xfrm flipV="1">
            <a:off x="8613320" y="2520607"/>
            <a:ext cx="0" cy="329293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62C93D54-DCAF-CCE1-DDFC-CF9C3D8F85F4}"/>
              </a:ext>
            </a:extLst>
          </p:cNvPr>
          <p:cNvSpPr txBox="1"/>
          <p:nvPr/>
        </p:nvSpPr>
        <p:spPr>
          <a:xfrm>
            <a:off x="4132200" y="2951589"/>
            <a:ext cx="12776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Patient admitted</a:t>
            </a:r>
          </a:p>
        </p:txBody>
      </p:sp>
      <p:sp>
        <p:nvSpPr>
          <p:cNvPr id="31" name="Down Arrow 30">
            <a:extLst>
              <a:ext uri="{FF2B5EF4-FFF2-40B4-BE49-F238E27FC236}">
                <a16:creationId xmlns:a16="http://schemas.microsoft.com/office/drawing/2014/main" id="{83B429A1-37B5-5C9F-06AB-6C5C98D1C585}"/>
              </a:ext>
            </a:extLst>
          </p:cNvPr>
          <p:cNvSpPr/>
          <p:nvPr/>
        </p:nvSpPr>
        <p:spPr>
          <a:xfrm>
            <a:off x="5585013" y="2503597"/>
            <a:ext cx="201047" cy="11949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41474B-B2AD-4B68-811B-275969D4BD42}"/>
              </a:ext>
            </a:extLst>
          </p:cNvPr>
          <p:cNvSpPr txBox="1"/>
          <p:nvPr/>
        </p:nvSpPr>
        <p:spPr>
          <a:xfrm>
            <a:off x="9055164" y="2856170"/>
            <a:ext cx="297050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linician </a:t>
            </a:r>
            <a:r>
              <a:rPr lang="en-US" sz="1400" b="1" dirty="0"/>
              <a:t>reviews existing ACP documentation</a:t>
            </a:r>
            <a:r>
              <a:rPr lang="en-US" sz="1400" dirty="0"/>
              <a:t>, discusses &amp; writes ACP update in context of new conditions, as appropriate</a:t>
            </a:r>
          </a:p>
        </p:txBody>
      </p:sp>
      <p:sp>
        <p:nvSpPr>
          <p:cNvPr id="10" name="Left Brace 9">
            <a:extLst>
              <a:ext uri="{FF2B5EF4-FFF2-40B4-BE49-F238E27FC236}">
                <a16:creationId xmlns:a16="http://schemas.microsoft.com/office/drawing/2014/main" id="{64D766F4-ECB3-7E0E-001B-1C2187FA6695}"/>
              </a:ext>
            </a:extLst>
          </p:cNvPr>
          <p:cNvSpPr/>
          <p:nvPr/>
        </p:nvSpPr>
        <p:spPr>
          <a:xfrm rot="16200000">
            <a:off x="3012752" y="1392057"/>
            <a:ext cx="471438" cy="4496868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ADB5BA9-4C61-E9D2-8E3C-45EBE56E528F}"/>
              </a:ext>
            </a:extLst>
          </p:cNvPr>
          <p:cNvSpPr txBox="1"/>
          <p:nvPr/>
        </p:nvSpPr>
        <p:spPr>
          <a:xfrm>
            <a:off x="6625127" y="3795486"/>
            <a:ext cx="1727372" cy="18158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linician </a:t>
            </a:r>
            <a:r>
              <a:rPr lang="en-US" sz="1400" b="1" dirty="0"/>
              <a:t>reviews existing ACP documentation</a:t>
            </a:r>
            <a:r>
              <a:rPr lang="en-US" sz="1400" dirty="0"/>
              <a:t>, discusses with family &amp; writes ACP update with change in condition to ensure goal aligned care</a:t>
            </a:r>
          </a:p>
        </p:txBody>
      </p:sp>
      <p:sp>
        <p:nvSpPr>
          <p:cNvPr id="13" name="Down Arrow 12">
            <a:extLst>
              <a:ext uri="{FF2B5EF4-FFF2-40B4-BE49-F238E27FC236}">
                <a16:creationId xmlns:a16="http://schemas.microsoft.com/office/drawing/2014/main" id="{2497D31D-6C30-3D47-3C60-3FB95C6ACD14}"/>
              </a:ext>
            </a:extLst>
          </p:cNvPr>
          <p:cNvSpPr/>
          <p:nvPr/>
        </p:nvSpPr>
        <p:spPr>
          <a:xfrm>
            <a:off x="7169683" y="2615361"/>
            <a:ext cx="201047" cy="11949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Down Arrow 13">
            <a:extLst>
              <a:ext uri="{FF2B5EF4-FFF2-40B4-BE49-F238E27FC236}">
                <a16:creationId xmlns:a16="http://schemas.microsoft.com/office/drawing/2014/main" id="{5B3D9DFD-A580-0A04-5D69-B7DAEFA1DCF6}"/>
              </a:ext>
            </a:extLst>
          </p:cNvPr>
          <p:cNvSpPr/>
          <p:nvPr/>
        </p:nvSpPr>
        <p:spPr>
          <a:xfrm rot="19569384">
            <a:off x="9002755" y="3026157"/>
            <a:ext cx="201047" cy="11949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18D4520-66B4-CE9B-03A6-5E94CB95C06E}"/>
              </a:ext>
            </a:extLst>
          </p:cNvPr>
          <p:cNvSpPr txBox="1"/>
          <p:nvPr/>
        </p:nvSpPr>
        <p:spPr>
          <a:xfrm>
            <a:off x="8311250" y="4064338"/>
            <a:ext cx="127767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Remain Critically</a:t>
            </a:r>
          </a:p>
          <a:p>
            <a:pPr algn="ctr"/>
            <a:r>
              <a:rPr lang="en-US" sz="1400" b="1" dirty="0"/>
              <a:t> Ill</a:t>
            </a:r>
          </a:p>
        </p:txBody>
      </p:sp>
      <p:sp>
        <p:nvSpPr>
          <p:cNvPr id="21" name="Down Arrow 20">
            <a:extLst>
              <a:ext uri="{FF2B5EF4-FFF2-40B4-BE49-F238E27FC236}">
                <a16:creationId xmlns:a16="http://schemas.microsoft.com/office/drawing/2014/main" id="{75916F47-C1A6-2A83-71D0-0ABA361AF484}"/>
              </a:ext>
            </a:extLst>
          </p:cNvPr>
          <p:cNvSpPr/>
          <p:nvPr/>
        </p:nvSpPr>
        <p:spPr>
          <a:xfrm rot="13660001">
            <a:off x="8940576" y="1398263"/>
            <a:ext cx="201047" cy="119491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67DB415-FCF7-EBDA-3AC6-75EAEACE7900}"/>
              </a:ext>
            </a:extLst>
          </p:cNvPr>
          <p:cNvSpPr/>
          <p:nvPr/>
        </p:nvSpPr>
        <p:spPr>
          <a:xfrm>
            <a:off x="9358278" y="4309384"/>
            <a:ext cx="2710544" cy="45194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Acute or Long Term Car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1B3D83A-9944-9174-4236-3858DB3D80B9}"/>
              </a:ext>
            </a:extLst>
          </p:cNvPr>
          <p:cNvSpPr txBox="1"/>
          <p:nvPr/>
        </p:nvSpPr>
        <p:spPr>
          <a:xfrm>
            <a:off x="9221496" y="5048048"/>
            <a:ext cx="297050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linician </a:t>
            </a:r>
            <a:r>
              <a:rPr lang="en-US" sz="1400" b="1" dirty="0"/>
              <a:t>reviews existing ACP documentation</a:t>
            </a:r>
            <a:r>
              <a:rPr lang="en-US" sz="1400" dirty="0"/>
              <a:t>, discusses &amp; writes ACP update in context of new conditions, as appropriate</a:t>
            </a:r>
          </a:p>
        </p:txBody>
      </p:sp>
    </p:spTree>
    <p:extLst>
      <p:ext uri="{BB962C8B-B14F-4D97-AF65-F5344CB8AC3E}">
        <p14:creationId xmlns:p14="http://schemas.microsoft.com/office/powerpoint/2010/main" val="923193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8</TotalTime>
  <Words>137</Words>
  <Application>Microsoft Macintosh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 Lin</dc:creator>
  <cp:lastModifiedBy>Sudore, Rebecca</cp:lastModifiedBy>
  <cp:revision>8</cp:revision>
  <dcterms:created xsi:type="dcterms:W3CDTF">2023-05-03T21:14:07Z</dcterms:created>
  <dcterms:modified xsi:type="dcterms:W3CDTF">2023-05-09T23:35:20Z</dcterms:modified>
</cp:coreProperties>
</file>